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258" r:id="rId2"/>
  </p:sldIdLst>
  <p:sldSz cx="15932150" cy="89614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97"/>
    <p:restoredTop sz="96715"/>
  </p:normalViewPr>
  <p:slideViewPr>
    <p:cSldViewPr snapToGrid="0" snapToObjects="1">
      <p:cViewPr varScale="1">
        <p:scale>
          <a:sx n="90" d="100"/>
          <a:sy n="90" d="100"/>
        </p:scale>
        <p:origin x="488" y="2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33E5502-1FBC-0042-B006-43458C8AC609}" type="datetimeFigureOut">
              <a:rPr lang="en-US" smtClean="0"/>
              <a:t>1/1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BF477B4-3C76-6F4B-A9D1-B28F2B1882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73969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991519" y="1466606"/>
            <a:ext cx="11949113" cy="3119908"/>
          </a:xfrm>
        </p:spPr>
        <p:txBody>
          <a:bodyPr anchor="b"/>
          <a:lstStyle>
            <a:lvl1pPr algn="ctr">
              <a:defRPr sz="78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991519" y="4706830"/>
            <a:ext cx="11949113" cy="2163606"/>
          </a:xfrm>
        </p:spPr>
        <p:txBody>
          <a:bodyPr/>
          <a:lstStyle>
            <a:lvl1pPr marL="0" indent="0" algn="ctr">
              <a:buNone/>
              <a:defRPr sz="3136"/>
            </a:lvl1pPr>
            <a:lvl2pPr marL="597423" indent="0" algn="ctr">
              <a:buNone/>
              <a:defRPr sz="2613"/>
            </a:lvl2pPr>
            <a:lvl3pPr marL="1194846" indent="0" algn="ctr">
              <a:buNone/>
              <a:defRPr sz="2352"/>
            </a:lvl3pPr>
            <a:lvl4pPr marL="1792270" indent="0" algn="ctr">
              <a:buNone/>
              <a:defRPr sz="2091"/>
            </a:lvl4pPr>
            <a:lvl5pPr marL="2389693" indent="0" algn="ctr">
              <a:buNone/>
              <a:defRPr sz="2091"/>
            </a:lvl5pPr>
            <a:lvl6pPr marL="2987116" indent="0" algn="ctr">
              <a:buNone/>
              <a:defRPr sz="2091"/>
            </a:lvl6pPr>
            <a:lvl7pPr marL="3584539" indent="0" algn="ctr">
              <a:buNone/>
              <a:defRPr sz="2091"/>
            </a:lvl7pPr>
            <a:lvl8pPr marL="4181963" indent="0" algn="ctr">
              <a:buNone/>
              <a:defRPr sz="2091"/>
            </a:lvl8pPr>
            <a:lvl9pPr marL="4779386" indent="0" algn="ctr">
              <a:buNone/>
              <a:defRPr sz="2091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889664-954F-594A-B5AF-FCA2FEB7744B}" type="datetimeFigureOut">
              <a:rPr lang="en-US" smtClean="0"/>
              <a:t>1/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1B486-F3E4-8B40-8B62-0DDBC71E83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21002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889664-954F-594A-B5AF-FCA2FEB7744B}" type="datetimeFigureOut">
              <a:rPr lang="en-US" smtClean="0"/>
              <a:t>1/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1B486-F3E4-8B40-8B62-0DDBC71E83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45471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401445" y="477114"/>
            <a:ext cx="3435370" cy="759440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95335" y="477114"/>
            <a:ext cx="10106958" cy="759440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889664-954F-594A-B5AF-FCA2FEB7744B}" type="datetimeFigureOut">
              <a:rPr lang="en-US" smtClean="0"/>
              <a:t>1/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1B486-F3E4-8B40-8B62-0DDBC71E83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39257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889664-954F-594A-B5AF-FCA2FEB7744B}" type="datetimeFigureOut">
              <a:rPr lang="en-US" smtClean="0"/>
              <a:t>1/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1B486-F3E4-8B40-8B62-0DDBC71E83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28232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87038" y="2234137"/>
            <a:ext cx="13741479" cy="3727709"/>
          </a:xfrm>
        </p:spPr>
        <p:txBody>
          <a:bodyPr anchor="b"/>
          <a:lstStyle>
            <a:lvl1pPr>
              <a:defRPr sz="78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87038" y="5997112"/>
            <a:ext cx="13741479" cy="1960314"/>
          </a:xfrm>
        </p:spPr>
        <p:txBody>
          <a:bodyPr/>
          <a:lstStyle>
            <a:lvl1pPr marL="0" indent="0">
              <a:buNone/>
              <a:defRPr sz="3136">
                <a:solidFill>
                  <a:schemeClr val="tx1">
                    <a:tint val="75000"/>
                  </a:schemeClr>
                </a:solidFill>
              </a:defRPr>
            </a:lvl1pPr>
            <a:lvl2pPr marL="597423" indent="0">
              <a:buNone/>
              <a:defRPr sz="2613">
                <a:solidFill>
                  <a:schemeClr val="tx1">
                    <a:tint val="75000"/>
                  </a:schemeClr>
                </a:solidFill>
              </a:defRPr>
            </a:lvl2pPr>
            <a:lvl3pPr marL="1194846" indent="0">
              <a:buNone/>
              <a:defRPr sz="2352">
                <a:solidFill>
                  <a:schemeClr val="tx1">
                    <a:tint val="75000"/>
                  </a:schemeClr>
                </a:solidFill>
              </a:defRPr>
            </a:lvl3pPr>
            <a:lvl4pPr marL="1792270" indent="0">
              <a:buNone/>
              <a:defRPr sz="2091">
                <a:solidFill>
                  <a:schemeClr val="tx1">
                    <a:tint val="75000"/>
                  </a:schemeClr>
                </a:solidFill>
              </a:defRPr>
            </a:lvl4pPr>
            <a:lvl5pPr marL="2389693" indent="0">
              <a:buNone/>
              <a:defRPr sz="2091">
                <a:solidFill>
                  <a:schemeClr val="tx1">
                    <a:tint val="75000"/>
                  </a:schemeClr>
                </a:solidFill>
              </a:defRPr>
            </a:lvl5pPr>
            <a:lvl6pPr marL="2987116" indent="0">
              <a:buNone/>
              <a:defRPr sz="2091">
                <a:solidFill>
                  <a:schemeClr val="tx1">
                    <a:tint val="75000"/>
                  </a:schemeClr>
                </a:solidFill>
              </a:defRPr>
            </a:lvl6pPr>
            <a:lvl7pPr marL="3584539" indent="0">
              <a:buNone/>
              <a:defRPr sz="2091">
                <a:solidFill>
                  <a:schemeClr val="tx1">
                    <a:tint val="75000"/>
                  </a:schemeClr>
                </a:solidFill>
              </a:defRPr>
            </a:lvl7pPr>
            <a:lvl8pPr marL="4181963" indent="0">
              <a:buNone/>
              <a:defRPr sz="2091">
                <a:solidFill>
                  <a:schemeClr val="tx1">
                    <a:tint val="75000"/>
                  </a:schemeClr>
                </a:solidFill>
              </a:defRPr>
            </a:lvl8pPr>
            <a:lvl9pPr marL="4779386" indent="0">
              <a:buNone/>
              <a:defRPr sz="209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889664-954F-594A-B5AF-FCA2FEB7744B}" type="datetimeFigureOut">
              <a:rPr lang="en-US" smtClean="0"/>
              <a:t>1/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1B486-F3E4-8B40-8B62-0DDBC71E83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18326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95335" y="2385568"/>
            <a:ext cx="6771164" cy="568595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065651" y="2385568"/>
            <a:ext cx="6771164" cy="568595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889664-954F-594A-B5AF-FCA2FEB7744B}" type="datetimeFigureOut">
              <a:rPr lang="en-US" smtClean="0"/>
              <a:t>1/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1B486-F3E4-8B40-8B62-0DDBC71E83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1590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97411" y="477114"/>
            <a:ext cx="13741479" cy="173213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97411" y="2196797"/>
            <a:ext cx="6740046" cy="1076617"/>
          </a:xfrm>
        </p:spPr>
        <p:txBody>
          <a:bodyPr anchor="b"/>
          <a:lstStyle>
            <a:lvl1pPr marL="0" indent="0">
              <a:buNone/>
              <a:defRPr sz="3136" b="1"/>
            </a:lvl1pPr>
            <a:lvl2pPr marL="597423" indent="0">
              <a:buNone/>
              <a:defRPr sz="2613" b="1"/>
            </a:lvl2pPr>
            <a:lvl3pPr marL="1194846" indent="0">
              <a:buNone/>
              <a:defRPr sz="2352" b="1"/>
            </a:lvl3pPr>
            <a:lvl4pPr marL="1792270" indent="0">
              <a:buNone/>
              <a:defRPr sz="2091" b="1"/>
            </a:lvl4pPr>
            <a:lvl5pPr marL="2389693" indent="0">
              <a:buNone/>
              <a:defRPr sz="2091" b="1"/>
            </a:lvl5pPr>
            <a:lvl6pPr marL="2987116" indent="0">
              <a:buNone/>
              <a:defRPr sz="2091" b="1"/>
            </a:lvl6pPr>
            <a:lvl7pPr marL="3584539" indent="0">
              <a:buNone/>
              <a:defRPr sz="2091" b="1"/>
            </a:lvl7pPr>
            <a:lvl8pPr marL="4181963" indent="0">
              <a:buNone/>
              <a:defRPr sz="2091" b="1"/>
            </a:lvl8pPr>
            <a:lvl9pPr marL="4779386" indent="0">
              <a:buNone/>
              <a:defRPr sz="209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97411" y="3273414"/>
            <a:ext cx="6740046" cy="481469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065651" y="2196797"/>
            <a:ext cx="6773239" cy="1076617"/>
          </a:xfrm>
        </p:spPr>
        <p:txBody>
          <a:bodyPr anchor="b"/>
          <a:lstStyle>
            <a:lvl1pPr marL="0" indent="0">
              <a:buNone/>
              <a:defRPr sz="3136" b="1"/>
            </a:lvl1pPr>
            <a:lvl2pPr marL="597423" indent="0">
              <a:buNone/>
              <a:defRPr sz="2613" b="1"/>
            </a:lvl2pPr>
            <a:lvl3pPr marL="1194846" indent="0">
              <a:buNone/>
              <a:defRPr sz="2352" b="1"/>
            </a:lvl3pPr>
            <a:lvl4pPr marL="1792270" indent="0">
              <a:buNone/>
              <a:defRPr sz="2091" b="1"/>
            </a:lvl4pPr>
            <a:lvl5pPr marL="2389693" indent="0">
              <a:buNone/>
              <a:defRPr sz="2091" b="1"/>
            </a:lvl5pPr>
            <a:lvl6pPr marL="2987116" indent="0">
              <a:buNone/>
              <a:defRPr sz="2091" b="1"/>
            </a:lvl6pPr>
            <a:lvl7pPr marL="3584539" indent="0">
              <a:buNone/>
              <a:defRPr sz="2091" b="1"/>
            </a:lvl7pPr>
            <a:lvl8pPr marL="4181963" indent="0">
              <a:buNone/>
              <a:defRPr sz="2091" b="1"/>
            </a:lvl8pPr>
            <a:lvl9pPr marL="4779386" indent="0">
              <a:buNone/>
              <a:defRPr sz="209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065651" y="3273414"/>
            <a:ext cx="6773239" cy="481469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889664-954F-594A-B5AF-FCA2FEB7744B}" type="datetimeFigureOut">
              <a:rPr lang="en-US" smtClean="0"/>
              <a:t>1/1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1B486-F3E4-8B40-8B62-0DDBC71E83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94842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889664-954F-594A-B5AF-FCA2FEB7744B}" type="datetimeFigureOut">
              <a:rPr lang="en-US" smtClean="0"/>
              <a:t>1/1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1B486-F3E4-8B40-8B62-0DDBC71E83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61838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889664-954F-594A-B5AF-FCA2FEB7744B}" type="datetimeFigureOut">
              <a:rPr lang="en-US" smtClean="0"/>
              <a:t>1/1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1B486-F3E4-8B40-8B62-0DDBC71E83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18782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97411" y="597429"/>
            <a:ext cx="5138533" cy="2091002"/>
          </a:xfrm>
        </p:spPr>
        <p:txBody>
          <a:bodyPr anchor="b"/>
          <a:lstStyle>
            <a:lvl1pPr>
              <a:defRPr sz="418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773239" y="1290282"/>
            <a:ext cx="8065651" cy="6368429"/>
          </a:xfrm>
        </p:spPr>
        <p:txBody>
          <a:bodyPr/>
          <a:lstStyle>
            <a:lvl1pPr>
              <a:defRPr sz="4181"/>
            </a:lvl1pPr>
            <a:lvl2pPr>
              <a:defRPr sz="3659"/>
            </a:lvl2pPr>
            <a:lvl3pPr>
              <a:defRPr sz="3136"/>
            </a:lvl3pPr>
            <a:lvl4pPr>
              <a:defRPr sz="2613"/>
            </a:lvl4pPr>
            <a:lvl5pPr>
              <a:defRPr sz="2613"/>
            </a:lvl5pPr>
            <a:lvl6pPr>
              <a:defRPr sz="2613"/>
            </a:lvl6pPr>
            <a:lvl7pPr>
              <a:defRPr sz="2613"/>
            </a:lvl7pPr>
            <a:lvl8pPr>
              <a:defRPr sz="2613"/>
            </a:lvl8pPr>
            <a:lvl9pPr>
              <a:defRPr sz="261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97411" y="2688431"/>
            <a:ext cx="5138533" cy="4980652"/>
          </a:xfrm>
        </p:spPr>
        <p:txBody>
          <a:bodyPr/>
          <a:lstStyle>
            <a:lvl1pPr marL="0" indent="0">
              <a:buNone/>
              <a:defRPr sz="2091"/>
            </a:lvl1pPr>
            <a:lvl2pPr marL="597423" indent="0">
              <a:buNone/>
              <a:defRPr sz="1829"/>
            </a:lvl2pPr>
            <a:lvl3pPr marL="1194846" indent="0">
              <a:buNone/>
              <a:defRPr sz="1568"/>
            </a:lvl3pPr>
            <a:lvl4pPr marL="1792270" indent="0">
              <a:buNone/>
              <a:defRPr sz="1307"/>
            </a:lvl4pPr>
            <a:lvl5pPr marL="2389693" indent="0">
              <a:buNone/>
              <a:defRPr sz="1307"/>
            </a:lvl5pPr>
            <a:lvl6pPr marL="2987116" indent="0">
              <a:buNone/>
              <a:defRPr sz="1307"/>
            </a:lvl6pPr>
            <a:lvl7pPr marL="3584539" indent="0">
              <a:buNone/>
              <a:defRPr sz="1307"/>
            </a:lvl7pPr>
            <a:lvl8pPr marL="4181963" indent="0">
              <a:buNone/>
              <a:defRPr sz="1307"/>
            </a:lvl8pPr>
            <a:lvl9pPr marL="4779386" indent="0">
              <a:buNone/>
              <a:defRPr sz="130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889664-954F-594A-B5AF-FCA2FEB7744B}" type="datetimeFigureOut">
              <a:rPr lang="en-US" smtClean="0"/>
              <a:t>1/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1B486-F3E4-8B40-8B62-0DDBC71E83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50046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97411" y="597429"/>
            <a:ext cx="5138533" cy="2091002"/>
          </a:xfrm>
        </p:spPr>
        <p:txBody>
          <a:bodyPr anchor="b"/>
          <a:lstStyle>
            <a:lvl1pPr>
              <a:defRPr sz="418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773239" y="1290282"/>
            <a:ext cx="8065651" cy="6368429"/>
          </a:xfrm>
        </p:spPr>
        <p:txBody>
          <a:bodyPr anchor="t"/>
          <a:lstStyle>
            <a:lvl1pPr marL="0" indent="0">
              <a:buNone/>
              <a:defRPr sz="4181"/>
            </a:lvl1pPr>
            <a:lvl2pPr marL="597423" indent="0">
              <a:buNone/>
              <a:defRPr sz="3659"/>
            </a:lvl2pPr>
            <a:lvl3pPr marL="1194846" indent="0">
              <a:buNone/>
              <a:defRPr sz="3136"/>
            </a:lvl3pPr>
            <a:lvl4pPr marL="1792270" indent="0">
              <a:buNone/>
              <a:defRPr sz="2613"/>
            </a:lvl4pPr>
            <a:lvl5pPr marL="2389693" indent="0">
              <a:buNone/>
              <a:defRPr sz="2613"/>
            </a:lvl5pPr>
            <a:lvl6pPr marL="2987116" indent="0">
              <a:buNone/>
              <a:defRPr sz="2613"/>
            </a:lvl6pPr>
            <a:lvl7pPr marL="3584539" indent="0">
              <a:buNone/>
              <a:defRPr sz="2613"/>
            </a:lvl7pPr>
            <a:lvl8pPr marL="4181963" indent="0">
              <a:buNone/>
              <a:defRPr sz="2613"/>
            </a:lvl8pPr>
            <a:lvl9pPr marL="4779386" indent="0">
              <a:buNone/>
              <a:defRPr sz="261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97411" y="2688431"/>
            <a:ext cx="5138533" cy="4980652"/>
          </a:xfrm>
        </p:spPr>
        <p:txBody>
          <a:bodyPr/>
          <a:lstStyle>
            <a:lvl1pPr marL="0" indent="0">
              <a:buNone/>
              <a:defRPr sz="2091"/>
            </a:lvl1pPr>
            <a:lvl2pPr marL="597423" indent="0">
              <a:buNone/>
              <a:defRPr sz="1829"/>
            </a:lvl2pPr>
            <a:lvl3pPr marL="1194846" indent="0">
              <a:buNone/>
              <a:defRPr sz="1568"/>
            </a:lvl3pPr>
            <a:lvl4pPr marL="1792270" indent="0">
              <a:buNone/>
              <a:defRPr sz="1307"/>
            </a:lvl4pPr>
            <a:lvl5pPr marL="2389693" indent="0">
              <a:buNone/>
              <a:defRPr sz="1307"/>
            </a:lvl5pPr>
            <a:lvl6pPr marL="2987116" indent="0">
              <a:buNone/>
              <a:defRPr sz="1307"/>
            </a:lvl6pPr>
            <a:lvl7pPr marL="3584539" indent="0">
              <a:buNone/>
              <a:defRPr sz="1307"/>
            </a:lvl7pPr>
            <a:lvl8pPr marL="4181963" indent="0">
              <a:buNone/>
              <a:defRPr sz="1307"/>
            </a:lvl8pPr>
            <a:lvl9pPr marL="4779386" indent="0">
              <a:buNone/>
              <a:defRPr sz="130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889664-954F-594A-B5AF-FCA2FEB7744B}" type="datetimeFigureOut">
              <a:rPr lang="en-US" smtClean="0"/>
              <a:t>1/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1B486-F3E4-8B40-8B62-0DDBC71E83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74220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95336" y="477114"/>
            <a:ext cx="13741479" cy="173213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95336" y="2385568"/>
            <a:ext cx="13741479" cy="56859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95335" y="8305926"/>
            <a:ext cx="3584734" cy="4771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6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889664-954F-594A-B5AF-FCA2FEB7744B}" type="datetimeFigureOut">
              <a:rPr lang="en-US" smtClean="0"/>
              <a:t>1/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277525" y="8305926"/>
            <a:ext cx="5377101" cy="4771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6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252081" y="8305926"/>
            <a:ext cx="3584734" cy="4771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6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51B486-F3E4-8B40-8B62-0DDBC71E83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51455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194846" rtl="0" eaLnBrk="1" latinLnBrk="0" hangingPunct="1">
        <a:lnSpc>
          <a:spcPct val="90000"/>
        </a:lnSpc>
        <a:spcBef>
          <a:spcPct val="0"/>
        </a:spcBef>
        <a:buNone/>
        <a:defRPr sz="574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8712" indent="-298712" algn="l" defTabSz="1194846" rtl="0" eaLnBrk="1" latinLnBrk="0" hangingPunct="1">
        <a:lnSpc>
          <a:spcPct val="90000"/>
        </a:lnSpc>
        <a:spcBef>
          <a:spcPts val="1307"/>
        </a:spcBef>
        <a:buFont typeface="Arial" panose="020B0604020202020204" pitchFamily="34" charset="0"/>
        <a:buChar char="•"/>
        <a:defRPr sz="3659" kern="1200">
          <a:solidFill>
            <a:schemeClr val="tx1"/>
          </a:solidFill>
          <a:latin typeface="+mn-lt"/>
          <a:ea typeface="+mn-ea"/>
          <a:cs typeface="+mn-cs"/>
        </a:defRPr>
      </a:lvl1pPr>
      <a:lvl2pPr marL="896135" indent="-298712" algn="l" defTabSz="1194846" rtl="0" eaLnBrk="1" latinLnBrk="0" hangingPunct="1">
        <a:lnSpc>
          <a:spcPct val="90000"/>
        </a:lnSpc>
        <a:spcBef>
          <a:spcPts val="653"/>
        </a:spcBef>
        <a:buFont typeface="Arial" panose="020B0604020202020204" pitchFamily="34" charset="0"/>
        <a:buChar char="•"/>
        <a:defRPr sz="3136" kern="1200">
          <a:solidFill>
            <a:schemeClr val="tx1"/>
          </a:solidFill>
          <a:latin typeface="+mn-lt"/>
          <a:ea typeface="+mn-ea"/>
          <a:cs typeface="+mn-cs"/>
        </a:defRPr>
      </a:lvl2pPr>
      <a:lvl3pPr marL="1493558" indent="-298712" algn="l" defTabSz="1194846" rtl="0" eaLnBrk="1" latinLnBrk="0" hangingPunct="1">
        <a:lnSpc>
          <a:spcPct val="90000"/>
        </a:lnSpc>
        <a:spcBef>
          <a:spcPts val="653"/>
        </a:spcBef>
        <a:buFont typeface="Arial" panose="020B0604020202020204" pitchFamily="34" charset="0"/>
        <a:buChar char="•"/>
        <a:defRPr sz="2613" kern="1200">
          <a:solidFill>
            <a:schemeClr val="tx1"/>
          </a:solidFill>
          <a:latin typeface="+mn-lt"/>
          <a:ea typeface="+mn-ea"/>
          <a:cs typeface="+mn-cs"/>
        </a:defRPr>
      </a:lvl3pPr>
      <a:lvl4pPr marL="2090981" indent="-298712" algn="l" defTabSz="1194846" rtl="0" eaLnBrk="1" latinLnBrk="0" hangingPunct="1">
        <a:lnSpc>
          <a:spcPct val="90000"/>
        </a:lnSpc>
        <a:spcBef>
          <a:spcPts val="653"/>
        </a:spcBef>
        <a:buFont typeface="Arial" panose="020B0604020202020204" pitchFamily="34" charset="0"/>
        <a:buChar char="•"/>
        <a:defRPr sz="2352" kern="1200">
          <a:solidFill>
            <a:schemeClr val="tx1"/>
          </a:solidFill>
          <a:latin typeface="+mn-lt"/>
          <a:ea typeface="+mn-ea"/>
          <a:cs typeface="+mn-cs"/>
        </a:defRPr>
      </a:lvl4pPr>
      <a:lvl5pPr marL="2688405" indent="-298712" algn="l" defTabSz="1194846" rtl="0" eaLnBrk="1" latinLnBrk="0" hangingPunct="1">
        <a:lnSpc>
          <a:spcPct val="90000"/>
        </a:lnSpc>
        <a:spcBef>
          <a:spcPts val="653"/>
        </a:spcBef>
        <a:buFont typeface="Arial" panose="020B0604020202020204" pitchFamily="34" charset="0"/>
        <a:buChar char="•"/>
        <a:defRPr sz="2352" kern="1200">
          <a:solidFill>
            <a:schemeClr val="tx1"/>
          </a:solidFill>
          <a:latin typeface="+mn-lt"/>
          <a:ea typeface="+mn-ea"/>
          <a:cs typeface="+mn-cs"/>
        </a:defRPr>
      </a:lvl5pPr>
      <a:lvl6pPr marL="3285828" indent="-298712" algn="l" defTabSz="1194846" rtl="0" eaLnBrk="1" latinLnBrk="0" hangingPunct="1">
        <a:lnSpc>
          <a:spcPct val="90000"/>
        </a:lnSpc>
        <a:spcBef>
          <a:spcPts val="653"/>
        </a:spcBef>
        <a:buFont typeface="Arial" panose="020B0604020202020204" pitchFamily="34" charset="0"/>
        <a:buChar char="•"/>
        <a:defRPr sz="2352" kern="1200">
          <a:solidFill>
            <a:schemeClr val="tx1"/>
          </a:solidFill>
          <a:latin typeface="+mn-lt"/>
          <a:ea typeface="+mn-ea"/>
          <a:cs typeface="+mn-cs"/>
        </a:defRPr>
      </a:lvl6pPr>
      <a:lvl7pPr marL="3883251" indent="-298712" algn="l" defTabSz="1194846" rtl="0" eaLnBrk="1" latinLnBrk="0" hangingPunct="1">
        <a:lnSpc>
          <a:spcPct val="90000"/>
        </a:lnSpc>
        <a:spcBef>
          <a:spcPts val="653"/>
        </a:spcBef>
        <a:buFont typeface="Arial" panose="020B0604020202020204" pitchFamily="34" charset="0"/>
        <a:buChar char="•"/>
        <a:defRPr sz="2352" kern="1200">
          <a:solidFill>
            <a:schemeClr val="tx1"/>
          </a:solidFill>
          <a:latin typeface="+mn-lt"/>
          <a:ea typeface="+mn-ea"/>
          <a:cs typeface="+mn-cs"/>
        </a:defRPr>
      </a:lvl7pPr>
      <a:lvl8pPr marL="4480674" indent="-298712" algn="l" defTabSz="1194846" rtl="0" eaLnBrk="1" latinLnBrk="0" hangingPunct="1">
        <a:lnSpc>
          <a:spcPct val="90000"/>
        </a:lnSpc>
        <a:spcBef>
          <a:spcPts val="653"/>
        </a:spcBef>
        <a:buFont typeface="Arial" panose="020B0604020202020204" pitchFamily="34" charset="0"/>
        <a:buChar char="•"/>
        <a:defRPr sz="2352" kern="1200">
          <a:solidFill>
            <a:schemeClr val="tx1"/>
          </a:solidFill>
          <a:latin typeface="+mn-lt"/>
          <a:ea typeface="+mn-ea"/>
          <a:cs typeface="+mn-cs"/>
        </a:defRPr>
      </a:lvl8pPr>
      <a:lvl9pPr marL="5078098" indent="-298712" algn="l" defTabSz="1194846" rtl="0" eaLnBrk="1" latinLnBrk="0" hangingPunct="1">
        <a:lnSpc>
          <a:spcPct val="90000"/>
        </a:lnSpc>
        <a:spcBef>
          <a:spcPts val="653"/>
        </a:spcBef>
        <a:buFont typeface="Arial" panose="020B0604020202020204" pitchFamily="34" charset="0"/>
        <a:buChar char="•"/>
        <a:defRPr sz="235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94846" rtl="0" eaLnBrk="1" latinLnBrk="0" hangingPunct="1">
        <a:defRPr sz="2352" kern="1200">
          <a:solidFill>
            <a:schemeClr val="tx1"/>
          </a:solidFill>
          <a:latin typeface="+mn-lt"/>
          <a:ea typeface="+mn-ea"/>
          <a:cs typeface="+mn-cs"/>
        </a:defRPr>
      </a:lvl1pPr>
      <a:lvl2pPr marL="597423" algn="l" defTabSz="1194846" rtl="0" eaLnBrk="1" latinLnBrk="0" hangingPunct="1">
        <a:defRPr sz="2352" kern="1200">
          <a:solidFill>
            <a:schemeClr val="tx1"/>
          </a:solidFill>
          <a:latin typeface="+mn-lt"/>
          <a:ea typeface="+mn-ea"/>
          <a:cs typeface="+mn-cs"/>
        </a:defRPr>
      </a:lvl2pPr>
      <a:lvl3pPr marL="1194846" algn="l" defTabSz="1194846" rtl="0" eaLnBrk="1" latinLnBrk="0" hangingPunct="1">
        <a:defRPr sz="2352" kern="1200">
          <a:solidFill>
            <a:schemeClr val="tx1"/>
          </a:solidFill>
          <a:latin typeface="+mn-lt"/>
          <a:ea typeface="+mn-ea"/>
          <a:cs typeface="+mn-cs"/>
        </a:defRPr>
      </a:lvl3pPr>
      <a:lvl4pPr marL="1792270" algn="l" defTabSz="1194846" rtl="0" eaLnBrk="1" latinLnBrk="0" hangingPunct="1">
        <a:defRPr sz="2352" kern="1200">
          <a:solidFill>
            <a:schemeClr val="tx1"/>
          </a:solidFill>
          <a:latin typeface="+mn-lt"/>
          <a:ea typeface="+mn-ea"/>
          <a:cs typeface="+mn-cs"/>
        </a:defRPr>
      </a:lvl4pPr>
      <a:lvl5pPr marL="2389693" algn="l" defTabSz="1194846" rtl="0" eaLnBrk="1" latinLnBrk="0" hangingPunct="1">
        <a:defRPr sz="2352" kern="1200">
          <a:solidFill>
            <a:schemeClr val="tx1"/>
          </a:solidFill>
          <a:latin typeface="+mn-lt"/>
          <a:ea typeface="+mn-ea"/>
          <a:cs typeface="+mn-cs"/>
        </a:defRPr>
      </a:lvl5pPr>
      <a:lvl6pPr marL="2987116" algn="l" defTabSz="1194846" rtl="0" eaLnBrk="1" latinLnBrk="0" hangingPunct="1">
        <a:defRPr sz="2352" kern="1200">
          <a:solidFill>
            <a:schemeClr val="tx1"/>
          </a:solidFill>
          <a:latin typeface="+mn-lt"/>
          <a:ea typeface="+mn-ea"/>
          <a:cs typeface="+mn-cs"/>
        </a:defRPr>
      </a:lvl6pPr>
      <a:lvl7pPr marL="3584539" algn="l" defTabSz="1194846" rtl="0" eaLnBrk="1" latinLnBrk="0" hangingPunct="1">
        <a:defRPr sz="2352" kern="1200">
          <a:solidFill>
            <a:schemeClr val="tx1"/>
          </a:solidFill>
          <a:latin typeface="+mn-lt"/>
          <a:ea typeface="+mn-ea"/>
          <a:cs typeface="+mn-cs"/>
        </a:defRPr>
      </a:lvl7pPr>
      <a:lvl8pPr marL="4181963" algn="l" defTabSz="1194846" rtl="0" eaLnBrk="1" latinLnBrk="0" hangingPunct="1">
        <a:defRPr sz="2352" kern="1200">
          <a:solidFill>
            <a:schemeClr val="tx1"/>
          </a:solidFill>
          <a:latin typeface="+mn-lt"/>
          <a:ea typeface="+mn-ea"/>
          <a:cs typeface="+mn-cs"/>
        </a:defRPr>
      </a:lvl8pPr>
      <a:lvl9pPr marL="4779386" algn="l" defTabSz="1194846" rtl="0" eaLnBrk="1" latinLnBrk="0" hangingPunct="1">
        <a:defRPr sz="235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image2.png">
            <a:extLst>
              <a:ext uri="{FF2B5EF4-FFF2-40B4-BE49-F238E27FC236}">
                <a16:creationId xmlns:a16="http://schemas.microsoft.com/office/drawing/2014/main" id="{949F0DF3-46CB-5040-B5B6-5B186E7949B9}"/>
              </a:ext>
            </a:extLst>
          </p:cNvPr>
          <p:cNvPicPr/>
          <p:nvPr/>
        </p:nvPicPr>
        <p:blipFill>
          <a:blip r:embed="rId2"/>
          <a:srcRect/>
          <a:stretch>
            <a:fillRect/>
          </a:stretch>
        </p:blipFill>
        <p:spPr>
          <a:xfrm>
            <a:off x="691848" y="1337824"/>
            <a:ext cx="14186747" cy="5907496"/>
          </a:xfrm>
          <a:prstGeom prst="rect">
            <a:avLst/>
          </a:prstGeom>
          <a:ln/>
        </p:spPr>
      </p:pic>
      <p:pic>
        <p:nvPicPr>
          <p:cNvPr id="9" name="image15.png">
            <a:extLst>
              <a:ext uri="{FF2B5EF4-FFF2-40B4-BE49-F238E27FC236}">
                <a16:creationId xmlns:a16="http://schemas.microsoft.com/office/drawing/2014/main" id="{4E769B3A-00AB-0C4B-A860-28CE618ED618}"/>
              </a:ext>
            </a:extLst>
          </p:cNvPr>
          <p:cNvPicPr/>
          <p:nvPr/>
        </p:nvPicPr>
        <p:blipFill>
          <a:blip r:embed="rId3"/>
          <a:srcRect/>
          <a:stretch>
            <a:fillRect/>
          </a:stretch>
        </p:blipFill>
        <p:spPr>
          <a:xfrm rot="16200000">
            <a:off x="7871560" y="-6050032"/>
            <a:ext cx="1327844" cy="7885872"/>
          </a:xfrm>
          <a:prstGeom prst="rect">
            <a:avLst/>
          </a:prstGeom>
          <a:ln/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92E87A75-B1F9-DB49-A8D7-601AF7622EE9}"/>
              </a:ext>
            </a:extLst>
          </p:cNvPr>
          <p:cNvSpPr/>
          <p:nvPr/>
        </p:nvSpPr>
        <p:spPr>
          <a:xfrm>
            <a:off x="691847" y="470826"/>
            <a:ext cx="13924265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</a:t>
            </a:r>
            <a:r>
              <a:rPr lang="en-US" sz="1600" b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able S</a:t>
            </a:r>
            <a:r>
              <a:rPr lang="en-US" sz="16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sz="1600" b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ne-way ANOVA analysis comparing expression of cytokines between Avelumab treated and Avelumab combined with Bevacizumab</a:t>
            </a:r>
          </a:p>
        </p:txBody>
      </p:sp>
    </p:spTree>
    <p:extLst>
      <p:ext uri="{BB962C8B-B14F-4D97-AF65-F5344CB8AC3E}">
        <p14:creationId xmlns:p14="http://schemas.microsoft.com/office/powerpoint/2010/main" val="11503376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33</TotalTime>
  <Words>19</Words>
  <Application>Microsoft Macintosh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ilia Hormigo</dc:creator>
  <cp:lastModifiedBy>Adilia Hormigo</cp:lastModifiedBy>
  <cp:revision>24</cp:revision>
  <dcterms:created xsi:type="dcterms:W3CDTF">2022-02-19T04:05:05Z</dcterms:created>
  <dcterms:modified xsi:type="dcterms:W3CDTF">2023-01-01T00:10:32Z</dcterms:modified>
</cp:coreProperties>
</file>